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  <p:sldId id="281" r:id="rId3"/>
    <p:sldId id="257" r:id="rId4"/>
    <p:sldId id="262" r:id="rId5"/>
    <p:sldId id="273" r:id="rId6"/>
    <p:sldId id="258" r:id="rId7"/>
    <p:sldId id="284" r:id="rId8"/>
    <p:sldId id="264" r:id="rId9"/>
    <p:sldId id="287" r:id="rId10"/>
    <p:sldId id="261" r:id="rId11"/>
    <p:sldId id="265" r:id="rId12"/>
    <p:sldId id="282" r:id="rId13"/>
    <p:sldId id="285" r:id="rId1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275" userDrawn="1">
          <p15:clr>
            <a:srgbClr val="A4A3A4"/>
          </p15:clr>
        </p15:guide>
        <p15:guide id="2" orient="horz" pos="2886" userDrawn="1">
          <p15:clr>
            <a:srgbClr val="A4A3A4"/>
          </p15:clr>
        </p15:guide>
        <p15:guide id="3" pos="5428" userDrawn="1">
          <p15:clr>
            <a:srgbClr val="A4A3A4"/>
          </p15:clr>
        </p15:guide>
        <p15:guide id="4" orient="horz" pos="9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61A89"/>
    <a:srgbClr val="AA72D4"/>
    <a:srgbClr val="FFEA10"/>
    <a:srgbClr val="4F4F25"/>
    <a:srgbClr val="0000FF"/>
    <a:srgbClr val="3D1010"/>
    <a:srgbClr val="FF1C02"/>
    <a:srgbClr val="FF8608"/>
    <a:srgbClr val="FFFF9E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21" autoAdjust="0"/>
    <p:restoredTop sz="94660"/>
  </p:normalViewPr>
  <p:slideViewPr>
    <p:cSldViewPr snapToGrid="0">
      <p:cViewPr varScale="1">
        <p:scale>
          <a:sx n="91" d="100"/>
          <a:sy n="91" d="100"/>
        </p:scale>
        <p:origin x="338" y="31"/>
      </p:cViewPr>
      <p:guideLst>
        <p:guide pos="2275"/>
        <p:guide orient="horz" pos="2886"/>
        <p:guide pos="5428"/>
        <p:guide orient="horz" pos="9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5824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2042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7160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8135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5983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743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84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6580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1804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5843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7703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385C6-81E9-4832-B16F-4F7EA482F34B}" type="datetimeFigureOut">
              <a:rPr lang="ko-KR" altLang="en-US" smtClean="0"/>
              <a:t>2020-04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814178-434C-453A-B36D-D4D76D5D40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9528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parkjgl@hanyang.ac.kr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36562" y="473127"/>
            <a:ext cx="11723426" cy="50456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for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A Double MgO-based Perpendicular Magnetic-Tunnel-Junction for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Artificial Neuron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altLang="ko-KR" dirty="0">
                <a:latin typeface="Arial" panose="020B0604020202020204" pitchFamily="34" charset="0"/>
              </a:rPr>
              <a:t>Dong Won Kim</a:t>
            </a:r>
            <a:r>
              <a:rPr lang="en-US" altLang="ko-KR" baseline="30000" dirty="0">
                <a:latin typeface="Arial" panose="020B0604020202020204" pitchFamily="34" charset="0"/>
              </a:rPr>
              <a:t>1</a:t>
            </a:r>
            <a:r>
              <a:rPr lang="en-US" altLang="ko-KR" dirty="0">
                <a:latin typeface="Arial" panose="020B0604020202020204" pitchFamily="34" charset="0"/>
              </a:rPr>
              <a:t>, Woo Seok Yi</a:t>
            </a:r>
            <a:r>
              <a:rPr lang="en-US" altLang="ko-KR" baseline="30000" dirty="0">
                <a:latin typeface="Arial" panose="020B0604020202020204" pitchFamily="34" charset="0"/>
              </a:rPr>
              <a:t>4</a:t>
            </a:r>
            <a:r>
              <a:rPr lang="en-US" altLang="ko-KR" dirty="0">
                <a:latin typeface="Arial" panose="020B0604020202020204" pitchFamily="34" charset="0"/>
              </a:rPr>
              <a:t>, </a:t>
            </a:r>
            <a:r>
              <a:rPr lang="en-US" altLang="ko-KR" dirty="0" err="1">
                <a:latin typeface="Arial" panose="020B0604020202020204" pitchFamily="34" charset="0"/>
              </a:rPr>
              <a:t>Jin</a:t>
            </a:r>
            <a:r>
              <a:rPr lang="en-US" altLang="ko-KR" dirty="0">
                <a:latin typeface="Arial" panose="020B0604020202020204" pitchFamily="34" charset="0"/>
              </a:rPr>
              <a:t> Young Choi</a:t>
            </a:r>
            <a:r>
              <a:rPr lang="en-US" altLang="ko-KR" baseline="30000" dirty="0">
                <a:latin typeface="Arial" panose="020B0604020202020204" pitchFamily="34" charset="0"/>
              </a:rPr>
              <a:t>2</a:t>
            </a:r>
            <a:r>
              <a:rPr lang="en-US" altLang="ko-KR" dirty="0">
                <a:latin typeface="Arial" panose="020B0604020202020204" pitchFamily="34" charset="0"/>
              </a:rPr>
              <a:t>, Kei Ashiba</a:t>
            </a:r>
            <a:r>
              <a:rPr lang="en-US" altLang="ko-KR" baseline="30000" dirty="0">
                <a:latin typeface="Arial" panose="020B0604020202020204" pitchFamily="34" charset="0"/>
              </a:rPr>
              <a:t>3</a:t>
            </a:r>
            <a:r>
              <a:rPr lang="en-US" altLang="ko-KR" dirty="0">
                <a:latin typeface="Arial" panose="020B0604020202020204" pitchFamily="34" charset="0"/>
              </a:rPr>
              <a:t>, Jong Ung Baek</a:t>
            </a:r>
            <a:r>
              <a:rPr lang="en-US" altLang="ko-KR" baseline="30000" dirty="0">
                <a:latin typeface="Arial" panose="020B0604020202020204" pitchFamily="34" charset="0"/>
              </a:rPr>
              <a:t>1</a:t>
            </a:r>
            <a:r>
              <a:rPr lang="en-US" altLang="ko-KR" dirty="0">
                <a:latin typeface="Arial" panose="020B0604020202020204" pitchFamily="34" charset="0"/>
              </a:rPr>
              <a:t>, Han Sol Jun</a:t>
            </a:r>
            <a:r>
              <a:rPr lang="en-US" altLang="ko-KR" baseline="30000" dirty="0">
                <a:latin typeface="Arial" panose="020B0604020202020204" pitchFamily="34" charset="0"/>
              </a:rPr>
              <a:t>1</a:t>
            </a:r>
            <a:r>
              <a:rPr lang="en-US" altLang="ko-KR" dirty="0">
                <a:latin typeface="Arial" panose="020B0604020202020204" pitchFamily="34" charset="0"/>
              </a:rPr>
              <a:t>,</a:t>
            </a:r>
            <a:r>
              <a:rPr lang="en-US" altLang="ko-KR" baseline="30000" dirty="0">
                <a:latin typeface="Arial" panose="020B0604020202020204" pitchFamily="34" charset="0"/>
              </a:rPr>
              <a:t>  </a:t>
            </a:r>
            <a:r>
              <a:rPr lang="en-US" altLang="ko-KR" dirty="0">
                <a:latin typeface="Arial" panose="020B0604020202020204" pitchFamily="34" charset="0"/>
              </a:rPr>
              <a:t>Jae Joon Kim</a:t>
            </a:r>
            <a:r>
              <a:rPr lang="en-US" altLang="ko-KR" baseline="30000" dirty="0">
                <a:latin typeface="Arial" panose="020B0604020202020204" pitchFamily="34" charset="0"/>
              </a:rPr>
              <a:t>4</a:t>
            </a:r>
            <a:r>
              <a:rPr lang="en-US" altLang="ko-KR" dirty="0">
                <a:latin typeface="Arial" panose="020B0604020202020204" pitchFamily="34" charset="0"/>
              </a:rPr>
              <a:t>, and </a:t>
            </a:r>
            <a:r>
              <a:rPr lang="en-US" altLang="ko-KR" dirty="0" err="1">
                <a:latin typeface="Arial" panose="020B0604020202020204" pitchFamily="34" charset="0"/>
              </a:rPr>
              <a:t>Jea</a:t>
            </a:r>
            <a:r>
              <a:rPr lang="en-US" altLang="ko-KR" dirty="0">
                <a:latin typeface="Arial" panose="020B0604020202020204" pitchFamily="34" charset="0"/>
              </a:rPr>
              <a:t> Gun Park</a:t>
            </a:r>
            <a:r>
              <a:rPr lang="en-US" altLang="ko-KR" baseline="30000" dirty="0">
                <a:latin typeface="Arial" panose="020B0604020202020204" pitchFamily="34" charset="0"/>
              </a:rPr>
              <a:t>1,2,*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baseline="30000" dirty="0">
                <a:solidFill>
                  <a:srgbClr val="000000"/>
                </a:solidFill>
                <a:latin typeface="Arial" panose="020B0604020202020204" pitchFamily="34" charset="0"/>
                <a:ea typeface="바탕" panose="02030600000101010101" pitchFamily="18" charset="-127"/>
              </a:rPr>
              <a:t>1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Department of Nanoscale Semiconductor Engineering, </a:t>
            </a:r>
            <a:r>
              <a:rPr lang="en-US" altLang="ko-KR" dirty="0" err="1">
                <a:solidFill>
                  <a:srgbClr val="000000"/>
                </a:solidFill>
                <a:latin typeface="Arial" panose="020B0604020202020204" pitchFamily="34" charset="0"/>
              </a:rPr>
              <a:t>Hanyang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 University, Seoul, 04763, Republic of Korea.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2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MRAM Center, Department of Electronics and Computer Engineering, </a:t>
            </a:r>
            <a:r>
              <a:rPr lang="en-US" altLang="ko-KR" dirty="0" err="1">
                <a:solidFill>
                  <a:srgbClr val="000000"/>
                </a:solidFill>
                <a:latin typeface="Arial" panose="020B0604020202020204" pitchFamily="34" charset="0"/>
              </a:rPr>
              <a:t>Hanyang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 University,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Seoul, 133-791, Republic of Korea.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3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Wafer Engineering Department, SUMCO CORPORATION, 1-52 </a:t>
            </a:r>
            <a:r>
              <a:rPr lang="en-US" altLang="ko-KR" dirty="0" err="1">
                <a:solidFill>
                  <a:srgbClr val="000000"/>
                </a:solidFill>
                <a:latin typeface="Arial" panose="020B0604020202020204" pitchFamily="34" charset="0"/>
              </a:rPr>
              <a:t>Kubara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altLang="ko-KR" dirty="0" err="1">
                <a:solidFill>
                  <a:srgbClr val="000000"/>
                </a:solidFill>
                <a:latin typeface="Arial" panose="020B0604020202020204" pitchFamily="34" charset="0"/>
              </a:rPr>
              <a:t>Imari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, Saga, 849-4256 Japan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4</a:t>
            </a:r>
            <a:r>
              <a:rPr lang="en-US" altLang="ko-KR" dirty="0">
                <a:solidFill>
                  <a:srgbClr val="000000"/>
                </a:solidFill>
                <a:latin typeface="Arial" panose="020B0604020202020204" pitchFamily="34" charset="0"/>
              </a:rPr>
              <a:t>Department of Creative IT Engineering, POSTECH Pohang, 37673, Republic of Korea.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sz="1600" dirty="0">
                <a:solidFill>
                  <a:srgbClr val="000000"/>
                </a:solidFill>
                <a:latin typeface="Arial" panose="020B0604020202020204" pitchFamily="34" charset="0"/>
              </a:rPr>
              <a:t> 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sz="1600" b="1" dirty="0">
                <a:solidFill>
                  <a:srgbClr val="000000"/>
                </a:solidFill>
                <a:latin typeface="Arial" panose="020B0604020202020204" pitchFamily="34" charset="0"/>
              </a:rPr>
              <a:t>*Corresponding author: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 latinLnBrk="0">
              <a:lnSpc>
                <a:spcPct val="107000"/>
              </a:lnSpc>
            </a:pPr>
            <a:r>
              <a:rPr lang="en-US" altLang="ko-KR" sz="1600" dirty="0" err="1">
                <a:solidFill>
                  <a:srgbClr val="000000"/>
                </a:solidFill>
                <a:latin typeface="Arial" panose="020B0604020202020204" pitchFamily="34" charset="0"/>
              </a:rPr>
              <a:t>Jea</a:t>
            </a:r>
            <a:r>
              <a:rPr lang="en-US" altLang="ko-KR" sz="1600" dirty="0">
                <a:solidFill>
                  <a:srgbClr val="000000"/>
                </a:solidFill>
                <a:latin typeface="Arial" panose="020B0604020202020204" pitchFamily="34" charset="0"/>
              </a:rPr>
              <a:t>-Gun Park</a:t>
            </a:r>
            <a:endParaRPr lang="ko-KR" altLang="ko-KR" dirty="0">
              <a:latin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altLang="ko-KR" sz="1600" dirty="0">
                <a:solidFill>
                  <a:srgbClr val="000000"/>
                </a:solidFill>
                <a:latin typeface="Arial" panose="020B0604020202020204" pitchFamily="34" charset="0"/>
              </a:rPr>
              <a:t>E-mail address: </a:t>
            </a:r>
            <a:r>
              <a:rPr lang="en-US" altLang="ko-KR" sz="1600" u="sng" dirty="0">
                <a:solidFill>
                  <a:srgbClr val="000000"/>
                </a:solidFill>
                <a:latin typeface="Arial" panose="020B0604020202020204" pitchFamily="34" charset="0"/>
                <a:hlinkClick r:id="rId2"/>
              </a:rPr>
              <a:t>parkjgl@hanyang.ac.kr</a:t>
            </a:r>
            <a:endParaRPr lang="ko-KR" altLang="ko-KR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55352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96569" y="5561086"/>
            <a:ext cx="58293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 |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Benchmarking between the reported CMOS based neuron circuits and our proposed p-STT MTJ neuron circuit.</a:t>
            </a:r>
            <a:endParaRPr lang="ko-KR" altLang="ko-KR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9326" y="410818"/>
            <a:ext cx="6614631" cy="5037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50702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474" y="909939"/>
            <a:ext cx="5445354" cy="430525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14840" y="867837"/>
            <a:ext cx="5556972" cy="432917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405394" y="5436685"/>
            <a:ext cx="56218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 |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Pattern recognition accuracy depending on reference resistance.</a:t>
            </a:r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61365" y="5436685"/>
            <a:ext cx="5315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 |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Pattern recognition accuracy depending on read error.</a:t>
            </a:r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01419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94334" y="0"/>
            <a:ext cx="11220451" cy="6588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Sengupta, A., Choday, S. H., Kim, Y., and Roy, K. (2015). Spin orbit torque based electronic neuron. Appl. Phys. Lett. 106, 143701. doi:10.1063/1.4917011.</a:t>
            </a:r>
            <a:endParaRPr lang="en-US" altLang="ko-KR" sz="1400" b="1" ker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2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Grollier, J., Querlioz, D., and Stiles, M. D. (2016). Spintronic Nanodevices for Bioinspired Computing. Proc. IEEE 104, 2024–2039. doi:10.1109/JPROC.2016.2597152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3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Srinivasan, G., Sengupta, A., and Roy, K. (2017). Magnetic tunnel junction enabled all-spin stochastic spiking neural network. Proc. 2017 Des. Autom. Test Eur. DATE 2017, 530–535. doi:10.23919/DATE.2017.7927045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4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Liyanagedera, C. M., Sengupta, A., Jaiswal, A., and Roy, K. (2017). Stochastic Spiking Neural Networks Enabled by Magnetic Tunnel Junctions: From Nontelegraphic to Telegraphic Switching Regimes. Phys. Rev. Appl. 8, 1–13. doi:10.1103/PhysRevApplied.8.064017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5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Shim, Y., Chen, S., Sengupta, A., and Roy, K. (2017). Stochastic Spin-Orbit Torque Devices as Elements for Bayesian Inference. Sci. Rep. 7, 1–9. doi:10.1038/s41598-017-14240-z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6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Romera, M., Talatchian, P., Tsunegi, S., Abreu Araujo, F., Cros, V., Bortolotti, P., et al. (2018). Vowel recognition with four coupled spin-torque nano-oscillators. Nature 563, 230–234. doi:10.1038/s41586-018-0632-y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7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Mizrahi, A., Grollier, J., Querlioz, D., and Stiles, M. D. (2018). Overcoming device unreliability with continuous learning in a population coding based computing system. J. Appl. Phys. 124. doi:10.1063/1.5042250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8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Riou, M., Torrejon, J., Garitaine, B., Abreu Araujo, F., Bortolotti, P., Cros, V., et al. (2019). Temporal pattern recognition with delayed-feedback spin-torque nano-oscillators. Phys. Rev. Appl. 12, 1. doi:10.1103/PhysRevApplied.12.024049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9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Kurenkov, A., DuttaGupta, S., Zhang, C., Fukami, S., Horio, Y., and Ohno, H. (2019). Artificial Neuron and Synapse Realized in an Antiferromagnet/Ferromagnet Heterostructure Using Dynamics of Spin–Orbit Torque Switching. Adv. Mater. 31, 1–7. doi:10.1002/adma.201900636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0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Tuma, T., Pantazi, A., Le Gallo, M., Sebastian, A., and Eleftheriou, E. (2016). Stochastic phase-change neurons. Nat. Nanotechnol. 11, 693–699. doi:10.1038/nnano.2016.70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1] 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Dutta, S., Kumar, V., Shukla, A., Mohapatra, N. R., and Ganguly, U. (2017). Leaky Integrate and Fire Neuron by Charge-Discharge Dynamics in Floating-Body MOSFET. Sci. Rep. 7, 8257. doi:10.1038/s41598-017-07418-y.</a:t>
            </a:r>
            <a:endParaRPr lang="ko-KR" altLang="ko-KR" sz="14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48120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94334" y="318052"/>
            <a:ext cx="11220451" cy="5728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2]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aosmanovic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., Chicca, E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rtele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kolajick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.,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esazeck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. (2018). Mimicking biological neurons with a nanoscale ferroelectric transistor. Nanoscale 10, 21755–21763. doi:10.1039/c8nr07135g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3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Hu, M. G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ttwald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Q. He, J. H. Park, G. Lauer, J. J. Nowak et al., (2017), 2017 IEDM, 38.31-38.34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4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rchuk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. Müller, S. Müller, J. Paul, M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ši´c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. V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um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(2016), IEEE Transactions on Electron Devices, 63, 9, pp. 3501-3507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i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0.1109/TED.2016.2588439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5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Sato, H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njo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. Watanabe, M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wa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. Koike, T. Saito et al., (2018), 14ns write speed 128Mb density Embedded STT-MRAM with endurance&gt;1010  and 10yrs retention @85°C using novel low damage MTJ integration process, 2018 IEDM, 27.2.1-27.2.4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6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eri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., Chicca, E., and Douglas, R. (2006). A VLSI array of low-power spiking neurons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stable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apses with spike-timing dependent plasticity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EEE Trans. Neural Networks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, 211–221. doi:10.1109/TNN.2005.860850.</a:t>
            </a:r>
            <a:endParaRPr lang="ko-KR" altLang="ko-KR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7]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jekoon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. H. B.,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dek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. (2008). Compact silicon neuron circuit with spiking and bursting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ral Networks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1, 524–534. doi:10.1016/j.neunet.2007.12.037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8]</a:t>
            </a:r>
            <a:r>
              <a:rPr lang="en-US" altLang="ko-KR" sz="1400" ker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u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.,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ler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. E. (2010).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llcline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design of a silicon neuron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EEE Trans. Circuits Syst. I </a:t>
            </a:r>
            <a:r>
              <a:rPr lang="en-US" altLang="ko-KR" sz="14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p.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, 2938–2947. doi:10.1109/TCSI.2010.2048772.</a:t>
            </a:r>
            <a:endParaRPr lang="ko-KR" altLang="ko-KR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19]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uz-Albrecht, J. M., Yung, M. W.,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inivasa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. (2012). Energy-efficient neuron, synapse and STDP integrated circuits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EEE Trans. Biomed. Circuits Syst.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, 246–256. doi:10.1109/TBCAS.2011.2174152.</a:t>
            </a:r>
            <a:endParaRPr lang="ko-KR" altLang="ko-KR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20] 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u, X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xena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., Zhu, K., and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agopal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. (2015). A CMOS Spiking Neuron for Brain-Inspired Neural Networks with Resistive Synapses and in Situ Learning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EEE Trans. Circuits Syst. II Express Briefs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2, 1088–1092. doi:10.1109/TCSII.2015.2456372.</a:t>
            </a: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0">
                <a:latin typeface="Times New Roman" panose="02020603050405020304" pitchFamily="18" charset="0"/>
                <a:cs typeface="Times New Roman" panose="02020603050405020304" pitchFamily="18" charset="0"/>
              </a:rPr>
              <a:t>[21]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ikopoulos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dayat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yez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nneville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., </a:t>
            </a:r>
            <a:r>
              <a:rPr lang="en-US" altLang="ko-KR" sz="14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el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., Mercier, E., et al. (2017). A 4-fJ/spike artificial neuron in 65 nm CMOS technology. 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nt. </a:t>
            </a:r>
            <a:r>
              <a:rPr lang="en-US" altLang="ko-KR" sz="14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sci</a:t>
            </a:r>
            <a:r>
              <a:rPr lang="en-US" altLang="ko-KR" sz="14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4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1, 1–14. doi:10.3389/fnins.2017.00123.</a:t>
            </a:r>
            <a:endParaRPr lang="ko-KR" altLang="ko-KR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04800" indent="-304800" latinLnBrk="0">
              <a:lnSpc>
                <a:spcPct val="107000"/>
              </a:lnSpc>
              <a:spcAft>
                <a:spcPts val="800"/>
              </a:spcAft>
            </a:pPr>
            <a:endParaRPr lang="ko-KR" altLang="ko-KR" sz="14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5474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/>
          <p:cNvSpPr txBox="1"/>
          <p:nvPr/>
        </p:nvSpPr>
        <p:spPr>
          <a:xfrm>
            <a:off x="2424841" y="5565596"/>
            <a:ext cx="80145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| Empirical integration model for p-STT MTJ neuron: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Logistic fitting of average 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ation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racteristics for 20 cells, (B) logistic fitting parameters depending on pulse amplitude, (C) measured integration curves and (D) simulated integration curves depending on pulse amplitude. 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7780" y="0"/>
            <a:ext cx="6779340" cy="5627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9962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48497" y="4890600"/>
            <a:ext cx="98470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| IGZO-based synapse device: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Schematic structure, 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I-V curve and 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potentiation/depression characteristic.   </a:t>
            </a:r>
            <a:endParaRPr lang="ko-KR" altLang="ko-K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그림 3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6537" y="1246837"/>
            <a:ext cx="9944248" cy="3341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7744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352451" y="5667727"/>
            <a:ext cx="738175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|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 Integrate-and-fire mechanism of the p-STT based neuron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: Grain size distribution of the </a:t>
            </a:r>
            <a:r>
              <a:rPr lang="en-US" altLang="ko-KR" err="1">
                <a:latin typeface="Times New Roman" panose="02020603050405020304" pitchFamily="18" charset="0"/>
                <a:cs typeface="Times New Roman" panose="02020603050405020304" pitchFamily="18" charset="0"/>
              </a:rPr>
              <a:t>MgO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tunneling barrier with an average size about 0.94 nm. </a:t>
            </a:r>
            <a:endParaRPr lang="ko-KR" altLang="ko-K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3786" y="648392"/>
            <a:ext cx="6380897" cy="4838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4722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9258" y="766734"/>
            <a:ext cx="6502439" cy="4717154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6" name="TextBox 15"/>
              <p:cNvSpPr txBox="1"/>
              <p:nvPr/>
            </p:nvSpPr>
            <p:spPr>
              <a:xfrm>
                <a:off x="2352451" y="5667727"/>
                <a:ext cx="7381754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4 </a:t>
                </a:r>
                <a:r>
                  <a:rPr lang="en-US" altLang="ko-KR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|</a:t>
                </a:r>
                <a:r>
                  <a:rPr lang="en-US" altLang="ko-KR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ain-size distribution of MgO tunneling barrier(i.e., ~1-nm in thickness) in a p-STT MTJ having 35</a:t>
                </a:r>
                <a14:m>
                  <m:oMath xmlns:m="http://schemas.openxmlformats.org/officeDocument/2006/math">
                    <m:r>
                      <a:rPr lang="en-US" altLang="ko-KR" i="1">
                        <a:latin typeface="Cambria Math" panose="02040503050406030204" pitchFamily="18" charset="0"/>
                        <a:ea typeface="Cambria Math" panose="02040503050406030204" pitchFamily="18" charset="0"/>
                        <a:cs typeface="Times New Roman" panose="02020603050405020304" pitchFamily="18" charset="0"/>
                      </a:rPr>
                      <m:t>×</m:t>
                    </m:r>
                  </m:oMath>
                </a14:m>
                <a:r>
                  <a:rPr lang="en-US" altLang="ko-KR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 nm</a:t>
                </a:r>
                <a:r>
                  <a:rPr lang="en-US" altLang="ko-KR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ko-KR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simulated from Supplementary Figure 3.</a:t>
                </a:r>
                <a:endParaRPr lang="ko-KR" altLang="ko-KR" baseline="30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/>
                <a:endParaRPr lang="ko-KR" altLang="ko-KR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16" name="TextBox 15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352451" y="5667727"/>
                <a:ext cx="7381754" cy="1200329"/>
              </a:xfrm>
              <a:prstGeom prst="rect">
                <a:avLst/>
              </a:prstGeom>
              <a:blipFill>
                <a:blip r:embed="rId3"/>
                <a:stretch>
                  <a:fillRect l="-743" t="-3046" r="-661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8087933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2744177" y="5359877"/>
            <a:ext cx="733085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 |</a:t>
            </a:r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Dependency of integration characteristic on the crystallinity of MgO tunneling barrier.</a:t>
            </a:r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 X-HR-TEM images of MgO tunneling barrier for sputtering power of (A) 260 W, (B) 290 W and (C) 320 W. R-V curves of p-STT MTJ dending on sputtering power of (D) 260 W, (E) 290 W and (F) 320 W. Integration characteristics of p-STT MTJ dending on sputtering power of (G) 260 W, (H) 290 W and (I) 320 W. </a:t>
            </a:r>
            <a:endParaRPr lang="ko-KR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그림 7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3455" y="8709"/>
            <a:ext cx="7093195" cy="5190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63723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24706" y="5595440"/>
            <a:ext cx="10606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</a:t>
            </a:r>
            <a:r>
              <a:rPr lang="en-US" altLang="ko-KR" b="1"/>
              <a:t>|</a:t>
            </a:r>
            <a:r>
              <a:rPr lang="en-US" altLang="ko-KR"/>
              <a:t> </a:t>
            </a: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Comparision our proposed p-STT MTJ neuron with other spin neurons.</a:t>
            </a:r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687" y="819150"/>
            <a:ext cx="10231599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32637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45210" y="3996310"/>
            <a:ext cx="11180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 |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 Power consumption comparison among other emerging neurons.</a:t>
            </a:r>
            <a:endParaRPr lang="ko-KR" altLang="ko-KR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61176" y="4520137"/>
            <a:ext cx="10363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* The possible pulse width of our work was 50 </a:t>
            </a:r>
            <a:r>
              <a:rPr lang="el-GR" altLang="ko-KR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μ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s.</a:t>
            </a:r>
          </a:p>
          <a:p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** The applied spike(pulse) amplitude of p-STT MTJ integrate-and-fire would be less than the pulse amplitude of the p-STT MTJ switch.</a:t>
            </a:r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382" y="516835"/>
            <a:ext cx="11417700" cy="3391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7645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82256" y="5382286"/>
            <a:ext cx="569482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 |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Layout design of neuron circuit(7 n-MOSFETs + 3 p-MOSFETs)  with 28-nm CMOS technology.</a:t>
            </a:r>
            <a:endParaRPr lang="ko-KR" altLang="ko-KR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7361" y="396133"/>
            <a:ext cx="4335779" cy="4922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8567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65</TotalTime>
  <Words>1609</Words>
  <Application>Microsoft Office PowerPoint</Application>
  <PresentationFormat>Widescreen</PresentationFormat>
  <Paragraphs>48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맑은 고딕</vt:lpstr>
      <vt:lpstr>Arial</vt:lpstr>
      <vt:lpstr>Cambria Math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SMDDC</dc:creator>
  <cp:lastModifiedBy>Lucie Senn</cp:lastModifiedBy>
  <cp:revision>75</cp:revision>
  <dcterms:created xsi:type="dcterms:W3CDTF">2020-02-26T00:48:07Z</dcterms:created>
  <dcterms:modified xsi:type="dcterms:W3CDTF">2020-04-27T13:20:32Z</dcterms:modified>
</cp:coreProperties>
</file>